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44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679" autoAdjust="0"/>
    <p:restoredTop sz="94660"/>
  </p:normalViewPr>
  <p:slideViewPr>
    <p:cSldViewPr snapToGrid="0">
      <p:cViewPr varScale="1">
        <p:scale>
          <a:sx n="70" d="100"/>
          <a:sy n="70" d="100"/>
        </p:scale>
        <p:origin x="708"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F:\PhD%20Backup\PhD\Results\iPS\Gene%20expression\Genewerk%20CRACK%20IT%20data\RT-qPCR\CrackIT_iPSC_analysi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F:\PhD%20Backup\PhD\Results\iPS\Gene%20expression\Genewerk%20CRACK%20IT%20data\RT-qPCR\CrackIT_iPSC_analysis.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GB" dirty="0" err="1"/>
              <a:t>pHR</a:t>
            </a:r>
            <a:endParaRPr lang="en-GB" dirty="0"/>
          </a:p>
        </c:rich>
      </c:tx>
      <c:layout>
        <c:manualLayout>
          <c:xMode val="edge"/>
          <c:yMode val="edge"/>
          <c:x val="0.48710733380589227"/>
          <c:y val="2.493547350192219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GB"/>
        </a:p>
      </c:txPr>
    </c:title>
    <c:autoTitleDeleted val="0"/>
    <c:plotArea>
      <c:layout/>
      <c:barChart>
        <c:barDir val="col"/>
        <c:grouping val="clustered"/>
        <c:varyColors val="0"/>
        <c:ser>
          <c:idx val="0"/>
          <c:order val="0"/>
          <c:spPr>
            <a:solidFill>
              <a:schemeClr val="accent1"/>
            </a:solidFill>
            <a:ln>
              <a:noFill/>
            </a:ln>
            <a:effectLst/>
          </c:spPr>
          <c:invertIfNegative val="0"/>
          <c:cat>
            <c:multiLvlStrRef>
              <c:f>'all in one'!$B$1:$AB$2</c:f>
              <c:multiLvlStrCache>
                <c:ptCount val="27"/>
                <c:lvl>
                  <c:pt idx="0">
                    <c:v>FMR1NB</c:v>
                  </c:pt>
                  <c:pt idx="1">
                    <c:v>FRAS1</c:v>
                  </c:pt>
                  <c:pt idx="2">
                    <c:v>FRAS1 (2)</c:v>
                  </c:pt>
                  <c:pt idx="3">
                    <c:v>DNAH7</c:v>
                  </c:pt>
                  <c:pt idx="4">
                    <c:v>DNAH7 (2)</c:v>
                  </c:pt>
                  <c:pt idx="5">
                    <c:v>OR52N4</c:v>
                  </c:pt>
                  <c:pt idx="6">
                    <c:v>DAZAP1</c:v>
                  </c:pt>
                  <c:pt idx="7">
                    <c:v>TMEM232</c:v>
                  </c:pt>
                  <c:pt idx="8">
                    <c:v>TMEM232 (2)</c:v>
                  </c:pt>
                  <c:pt idx="9">
                    <c:v>CTNNA3</c:v>
                  </c:pt>
                  <c:pt idx="10">
                    <c:v>CTNNA3 (2)</c:v>
                  </c:pt>
                  <c:pt idx="11">
                    <c:v>WDFY2</c:v>
                  </c:pt>
                  <c:pt idx="12">
                    <c:v>BASP1P1</c:v>
                  </c:pt>
                  <c:pt idx="13">
                    <c:v>BASP1P1</c:v>
                  </c:pt>
                  <c:pt idx="14">
                    <c:v>BASP1P1 (2)</c:v>
                  </c:pt>
                  <c:pt idx="15">
                    <c:v>MGAT4C</c:v>
                  </c:pt>
                  <c:pt idx="16">
                    <c:v>MAPK10</c:v>
                  </c:pt>
                  <c:pt idx="17">
                    <c:v>FGF14</c:v>
                  </c:pt>
                  <c:pt idx="18">
                    <c:v>TMEM189</c:v>
                  </c:pt>
                  <c:pt idx="19">
                    <c:v>DANCR</c:v>
                  </c:pt>
                  <c:pt idx="20">
                    <c:v>CTC1</c:v>
                  </c:pt>
                  <c:pt idx="21">
                    <c:v>CTC1 (2)</c:v>
                  </c:pt>
                  <c:pt idx="22">
                    <c:v>GRID2</c:v>
                  </c:pt>
                  <c:pt idx="23">
                    <c:v>CTC1</c:v>
                  </c:pt>
                  <c:pt idx="24">
                    <c:v>CTC2 (2)</c:v>
                  </c:pt>
                  <c:pt idx="25">
                    <c:v>DANCR</c:v>
                  </c:pt>
                  <c:pt idx="26">
                    <c:v>PCGF3</c:v>
                  </c:pt>
                </c:lvl>
                <c:lvl>
                  <c:pt idx="0">
                    <c:v>F</c:v>
                  </c:pt>
                  <c:pt idx="6">
                    <c:v>G</c:v>
                  </c:pt>
                  <c:pt idx="9">
                    <c:v>H</c:v>
                  </c:pt>
                  <c:pt idx="13">
                    <c:v>K</c:v>
                  </c:pt>
                  <c:pt idx="19">
                    <c:v>Q</c:v>
                  </c:pt>
                  <c:pt idx="22">
                    <c:v>R</c:v>
                  </c:pt>
                  <c:pt idx="23">
                    <c:v>V</c:v>
                  </c:pt>
                </c:lvl>
              </c:multiLvlStrCache>
            </c:multiLvlStrRef>
          </c:cat>
          <c:val>
            <c:numRef>
              <c:f>'all in one'!$B$3:$AB$3</c:f>
              <c:numCache>
                <c:formatCode>General</c:formatCode>
                <c:ptCount val="27"/>
                <c:pt idx="0">
                  <c:v>117</c:v>
                </c:pt>
                <c:pt idx="1">
                  <c:v>21</c:v>
                </c:pt>
                <c:pt idx="2">
                  <c:v>17</c:v>
                </c:pt>
                <c:pt idx="3">
                  <c:v>372</c:v>
                </c:pt>
                <c:pt idx="4">
                  <c:v>375</c:v>
                </c:pt>
                <c:pt idx="5">
                  <c:v>173</c:v>
                </c:pt>
                <c:pt idx="6">
                  <c:v>91</c:v>
                </c:pt>
                <c:pt idx="7">
                  <c:v>25</c:v>
                </c:pt>
                <c:pt idx="8">
                  <c:v>30</c:v>
                </c:pt>
                <c:pt idx="9">
                  <c:v>39</c:v>
                </c:pt>
                <c:pt idx="10">
                  <c:v>40</c:v>
                </c:pt>
                <c:pt idx="11">
                  <c:v>73</c:v>
                </c:pt>
                <c:pt idx="12">
                  <c:v>102</c:v>
                </c:pt>
                <c:pt idx="13">
                  <c:v>322</c:v>
                </c:pt>
                <c:pt idx="14">
                  <c:v>254</c:v>
                </c:pt>
                <c:pt idx="15">
                  <c:v>209</c:v>
                </c:pt>
                <c:pt idx="16">
                  <c:v>156</c:v>
                </c:pt>
                <c:pt idx="17">
                  <c:v>105</c:v>
                </c:pt>
                <c:pt idx="18">
                  <c:v>157</c:v>
                </c:pt>
                <c:pt idx="19">
                  <c:v>88</c:v>
                </c:pt>
                <c:pt idx="20">
                  <c:v>27</c:v>
                </c:pt>
                <c:pt idx="21">
                  <c:v>37</c:v>
                </c:pt>
                <c:pt idx="22">
                  <c:v>98</c:v>
                </c:pt>
                <c:pt idx="23">
                  <c:v>25</c:v>
                </c:pt>
                <c:pt idx="24">
                  <c:v>26</c:v>
                </c:pt>
                <c:pt idx="25">
                  <c:v>66</c:v>
                </c:pt>
                <c:pt idx="26">
                  <c:v>59</c:v>
                </c:pt>
              </c:numCache>
            </c:numRef>
          </c:val>
          <c:extLst>
            <c:ext xmlns:c16="http://schemas.microsoft.com/office/drawing/2014/chart" uri="{C3380CC4-5D6E-409C-BE32-E72D297353CC}">
              <c16:uniqueId val="{00000000-B03A-4FFB-9575-A05D944CBBF4}"/>
            </c:ext>
          </c:extLst>
        </c:ser>
        <c:dLbls>
          <c:showLegendKey val="0"/>
          <c:showVal val="0"/>
          <c:showCatName val="0"/>
          <c:showSerName val="0"/>
          <c:showPercent val="0"/>
          <c:showBubbleSize val="0"/>
        </c:dLbls>
        <c:gapWidth val="219"/>
        <c:overlap val="-27"/>
        <c:axId val="615782456"/>
        <c:axId val="615784752"/>
      </c:barChart>
      <c:catAx>
        <c:axId val="6157824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GB" dirty="0"/>
                  <a:t>Clon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15784752"/>
        <c:crosses val="autoZero"/>
        <c:auto val="1"/>
        <c:lblAlgn val="ctr"/>
        <c:lblOffset val="100"/>
        <c:noMultiLvlLbl val="0"/>
      </c:catAx>
      <c:valAx>
        <c:axId val="61578475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GB" dirty="0"/>
                  <a:t>Relative expression</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1578245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GB" dirty="0" err="1"/>
              <a:t>pHV</a:t>
            </a:r>
            <a:endParaRPr lang="en-GB" dirty="0"/>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GB"/>
        </a:p>
      </c:txPr>
    </c:title>
    <c:autoTitleDeleted val="0"/>
    <c:plotArea>
      <c:layout/>
      <c:barChart>
        <c:barDir val="col"/>
        <c:grouping val="clustered"/>
        <c:varyColors val="0"/>
        <c:ser>
          <c:idx val="0"/>
          <c:order val="0"/>
          <c:spPr>
            <a:solidFill>
              <a:schemeClr val="accent1"/>
            </a:solidFill>
            <a:ln>
              <a:noFill/>
            </a:ln>
            <a:effectLst/>
          </c:spPr>
          <c:invertIfNegative val="0"/>
          <c:cat>
            <c:multiLvlStrRef>
              <c:f>'all in one'!$B$28:$AD$29</c:f>
              <c:multiLvlStrCache>
                <c:ptCount val="29"/>
                <c:lvl>
                  <c:pt idx="0">
                    <c:v>ATRNL1</c:v>
                  </c:pt>
                  <c:pt idx="1">
                    <c:v>IP6K1</c:v>
                  </c:pt>
                  <c:pt idx="2">
                    <c:v>ANGPT1</c:v>
                  </c:pt>
                  <c:pt idx="3">
                    <c:v>ZMYM4</c:v>
                  </c:pt>
                  <c:pt idx="4">
                    <c:v>VBP1</c:v>
                  </c:pt>
                  <c:pt idx="5">
                    <c:v>FUT9</c:v>
                  </c:pt>
                  <c:pt idx="6">
                    <c:v>MIR4431</c:v>
                  </c:pt>
                  <c:pt idx="7">
                    <c:v>NLGN4X</c:v>
                  </c:pt>
                  <c:pt idx="8">
                    <c:v>IRAK1</c:v>
                  </c:pt>
                  <c:pt idx="9">
                    <c:v>RPS6KA4</c:v>
                  </c:pt>
                  <c:pt idx="10">
                    <c:v>FRYL</c:v>
                  </c:pt>
                  <c:pt idx="11">
                    <c:v>LEF1</c:v>
                  </c:pt>
                  <c:pt idx="12">
                    <c:v>IL26</c:v>
                  </c:pt>
                  <c:pt idx="13">
                    <c:v>AXIN1</c:v>
                  </c:pt>
                  <c:pt idx="14">
                    <c:v>LINC01571</c:v>
                  </c:pt>
                  <c:pt idx="15">
                    <c:v>MED13L</c:v>
                  </c:pt>
                  <c:pt idx="16">
                    <c:v>SOX8</c:v>
                  </c:pt>
                  <c:pt idx="17">
                    <c:v>THTPA</c:v>
                  </c:pt>
                  <c:pt idx="18">
                    <c:v>CASC6</c:v>
                  </c:pt>
                  <c:pt idx="19">
                    <c:v>CSK</c:v>
                  </c:pt>
                  <c:pt idx="20">
                    <c:v>RBFOX3</c:v>
                  </c:pt>
                  <c:pt idx="21">
                    <c:v>VPS13C</c:v>
                  </c:pt>
                  <c:pt idx="22">
                    <c:v>ANKRD11</c:v>
                  </c:pt>
                  <c:pt idx="23">
                    <c:v>LINC01249</c:v>
                  </c:pt>
                  <c:pt idx="24">
                    <c:v>PLCG1</c:v>
                  </c:pt>
                  <c:pt idx="25">
                    <c:v>ADAM21P1</c:v>
                  </c:pt>
                  <c:pt idx="26">
                    <c:v>LINC01249</c:v>
                  </c:pt>
                  <c:pt idx="27">
                    <c:v>MGAT4C</c:v>
                  </c:pt>
                  <c:pt idx="28">
                    <c:v>MARS</c:v>
                  </c:pt>
                </c:lvl>
                <c:lvl>
                  <c:pt idx="0">
                    <c:v>1</c:v>
                  </c:pt>
                  <c:pt idx="8">
                    <c:v>2</c:v>
                  </c:pt>
                  <c:pt idx="13">
                    <c:v>4</c:v>
                  </c:pt>
                  <c:pt idx="23">
                    <c:v>6</c:v>
                  </c:pt>
                </c:lvl>
              </c:multiLvlStrCache>
            </c:multiLvlStrRef>
          </c:cat>
          <c:val>
            <c:numRef>
              <c:f>'all in one'!$B$30:$AD$30</c:f>
              <c:numCache>
                <c:formatCode>General</c:formatCode>
                <c:ptCount val="29"/>
                <c:pt idx="0">
                  <c:v>34.451999999999998</c:v>
                </c:pt>
                <c:pt idx="1">
                  <c:v>25.283999999999999</c:v>
                </c:pt>
                <c:pt idx="2">
                  <c:v>21.835999999999999</c:v>
                </c:pt>
                <c:pt idx="3">
                  <c:v>7.1989999999999998</c:v>
                </c:pt>
                <c:pt idx="4">
                  <c:v>1.3140000000000001</c:v>
                </c:pt>
                <c:pt idx="5">
                  <c:v>0.98</c:v>
                </c:pt>
                <c:pt idx="6">
                  <c:v>0.94699999999999995</c:v>
                </c:pt>
                <c:pt idx="7">
                  <c:v>0.21099999999999999</c:v>
                </c:pt>
                <c:pt idx="8">
                  <c:v>29.472000000000001</c:v>
                </c:pt>
                <c:pt idx="9">
                  <c:v>28.588999999999999</c:v>
                </c:pt>
                <c:pt idx="10">
                  <c:v>22.486000000000001</c:v>
                </c:pt>
                <c:pt idx="11">
                  <c:v>11.839</c:v>
                </c:pt>
                <c:pt idx="12">
                  <c:v>7.11</c:v>
                </c:pt>
                <c:pt idx="13">
                  <c:v>25.902999999999999</c:v>
                </c:pt>
                <c:pt idx="14">
                  <c:v>13.497999999999999</c:v>
                </c:pt>
                <c:pt idx="15">
                  <c:v>11.186999999999999</c:v>
                </c:pt>
                <c:pt idx="16">
                  <c:v>10.163</c:v>
                </c:pt>
                <c:pt idx="17">
                  <c:v>7.5119999999999996</c:v>
                </c:pt>
                <c:pt idx="18">
                  <c:v>6.1139999999999999</c:v>
                </c:pt>
                <c:pt idx="19">
                  <c:v>5.008</c:v>
                </c:pt>
                <c:pt idx="20">
                  <c:v>4.8179999999999996</c:v>
                </c:pt>
                <c:pt idx="21">
                  <c:v>4.1520000000000001</c:v>
                </c:pt>
                <c:pt idx="22">
                  <c:v>3.65</c:v>
                </c:pt>
                <c:pt idx="23">
                  <c:v>93.453999999999994</c:v>
                </c:pt>
                <c:pt idx="24">
                  <c:v>4.1189999999999998</c:v>
                </c:pt>
                <c:pt idx="25">
                  <c:v>0.56899999999999995</c:v>
                </c:pt>
                <c:pt idx="26">
                  <c:v>0.31900000000000001</c:v>
                </c:pt>
                <c:pt idx="27">
                  <c:v>0.13500000000000001</c:v>
                </c:pt>
                <c:pt idx="28">
                  <c:v>1E-3</c:v>
                </c:pt>
              </c:numCache>
            </c:numRef>
          </c:val>
          <c:extLst>
            <c:ext xmlns:c16="http://schemas.microsoft.com/office/drawing/2014/chart" uri="{C3380CC4-5D6E-409C-BE32-E72D297353CC}">
              <c16:uniqueId val="{00000000-47B5-4AED-A52A-B32944CA5E88}"/>
            </c:ext>
          </c:extLst>
        </c:ser>
        <c:dLbls>
          <c:showLegendKey val="0"/>
          <c:showVal val="0"/>
          <c:showCatName val="0"/>
          <c:showSerName val="0"/>
          <c:showPercent val="0"/>
          <c:showBubbleSize val="0"/>
        </c:dLbls>
        <c:gapWidth val="219"/>
        <c:overlap val="-27"/>
        <c:axId val="467744296"/>
        <c:axId val="467742000"/>
      </c:barChart>
      <c:catAx>
        <c:axId val="46774429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GB" dirty="0"/>
                  <a:t>Clone</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67742000"/>
        <c:crosses val="autoZero"/>
        <c:auto val="1"/>
        <c:lblAlgn val="ctr"/>
        <c:lblOffset val="100"/>
        <c:noMultiLvlLbl val="0"/>
      </c:catAx>
      <c:valAx>
        <c:axId val="46774200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GB" dirty="0"/>
                  <a:t>Relative expression</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6774429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7EBD81-DDCF-4394-9D53-15499AAC64DC}" type="datetimeFigureOut">
              <a:rPr lang="en-GB" smtClean="0"/>
              <a:t>15/04/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4EFCC3-C08D-42E9-AE17-D801792739C0}" type="slidenum">
              <a:rPr lang="en-GB" smtClean="0"/>
              <a:t>‹#›</a:t>
            </a:fld>
            <a:endParaRPr lang="en-GB"/>
          </a:p>
        </p:txBody>
      </p:sp>
    </p:spTree>
    <p:extLst>
      <p:ext uri="{BB962C8B-B14F-4D97-AF65-F5344CB8AC3E}">
        <p14:creationId xmlns:p14="http://schemas.microsoft.com/office/powerpoint/2010/main" val="3703360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CD5166-24B3-4E19-B995-E052CAF2FD4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50A9420C-74C9-49BB-AD41-28EE86C5870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9BC8B18-351C-48E0-9472-A630922949E3}"/>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A5E053A5-2EE6-4B5B-8C68-7AEFBAB58CE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05936FA-2ECA-4E12-972C-072926AACB1B}"/>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225836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DB603-F780-4278-B99F-10B213E58F87}"/>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1824337-225E-4619-AD80-82B24D9805BB}"/>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4CBD175-7A87-4606-B941-02F2CC391D34}"/>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01C3B324-66A8-4E27-AB83-83D80A71474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F3F7DD6-8B32-49D5-8C6C-67425064CF8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180331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758E29-E635-4399-9CD9-46327BC7CB5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36CAEA6-0304-4E7E-8DD9-4E7B3FDE731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8822AF5-7E5B-41E4-BB84-26BB63BB62AD}"/>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DC7E407D-22C3-4181-9B8D-6F578826403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8F47847-837C-4827-8211-DE386ABD2039}"/>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1140945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F984A5-DD37-4F65-A5C6-00D49147545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9A43F39-45A7-4064-9419-38FA43480AF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EBCFF4C-3DBE-4D7D-9D82-2B7311D9B2C6}"/>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64296C82-54D2-4335-B75E-98F7FD02AE4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A0A9AE4-4915-4B70-ADF9-8803E011B617}"/>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786457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1FF222-E43C-497F-A8A0-86E98E72D63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5078A5E-6C7F-4F2A-BC05-AF16FFE720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29085B8-86A9-4E5F-BBFC-BBD99D9D0AF0}"/>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E3B3B987-0B15-4835-9466-D378DC5DCF7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1C07BE3-A330-4B3F-B8C8-221544BB300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7956821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AC8D33-B9CE-4060-86FF-D1E63DF072D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42BDDC4-9E2C-470E-8614-FEF2C0C06F9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813CA981-C392-4CD8-874B-E445CA860D3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F4B2A15-259B-4351-97D8-AED26DAA9D9F}"/>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6" name="Footer Placeholder 5">
            <a:extLst>
              <a:ext uri="{FF2B5EF4-FFF2-40B4-BE49-F238E27FC236}">
                <a16:creationId xmlns:a16="http://schemas.microsoft.com/office/drawing/2014/main" id="{FA4A461E-7716-4F2C-A590-7E9C5F5BC18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360FD94-D0BF-4462-839C-302621E15F21}"/>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1900076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C4A57A-19A1-4077-8939-730B5FFA5B1A}"/>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C92A289-EDA8-44A2-BDF5-D7CF7A68894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8992B2CC-1EE1-4F01-B2D8-3F590759154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3E5D7109-7E5E-4123-A877-9B5072C05A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279AE05-E585-4FEB-9FE4-5780487C8C3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9FF49309-17B0-433A-86BE-A146548FADDF}"/>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8" name="Footer Placeholder 7">
            <a:extLst>
              <a:ext uri="{FF2B5EF4-FFF2-40B4-BE49-F238E27FC236}">
                <a16:creationId xmlns:a16="http://schemas.microsoft.com/office/drawing/2014/main" id="{39FD9909-C228-4A80-8EE4-4220326047EF}"/>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67FB830-4967-4887-832C-6DE14DA726AC}"/>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040569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78A0D-C8D7-41CD-9131-0FBA2A421CF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75EA9B54-893B-4E50-94CD-8053CD06B51E}"/>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4" name="Footer Placeholder 3">
            <a:extLst>
              <a:ext uri="{FF2B5EF4-FFF2-40B4-BE49-F238E27FC236}">
                <a16:creationId xmlns:a16="http://schemas.microsoft.com/office/drawing/2014/main" id="{495BE61D-B329-4B2D-8E6C-4CBF322A26D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0AA6BEC3-86B4-447C-A9EA-F11ADA3D8502}"/>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829588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314AE8A-D537-443B-97FE-D0A73B4506A9}"/>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3" name="Footer Placeholder 2">
            <a:extLst>
              <a:ext uri="{FF2B5EF4-FFF2-40B4-BE49-F238E27FC236}">
                <a16:creationId xmlns:a16="http://schemas.microsoft.com/office/drawing/2014/main" id="{B0F0BA55-1FEE-4324-9EA5-0596C0B5DCF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136D1075-0534-4C35-AA88-2767F453602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6426442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8152F-F243-4D26-9E4A-DA17E8B2658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5B3255A-4C51-4196-A55C-F8E6119A96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D006397-CE0B-4D42-9B8A-296B2A0EA0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456B42B-99D5-45EE-8825-3C877B033988}"/>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6" name="Footer Placeholder 5">
            <a:extLst>
              <a:ext uri="{FF2B5EF4-FFF2-40B4-BE49-F238E27FC236}">
                <a16:creationId xmlns:a16="http://schemas.microsoft.com/office/drawing/2014/main" id="{F71BCDF0-27C7-4BEF-BF33-BBB1F02D45B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F0076C0-854F-47BF-8811-28B3A6675603}"/>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095128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5E49C9-BFAD-446C-809A-6BA92E4238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636115C-F9B9-4CF2-BD07-B2ED49320CE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3AC80B9A-0C94-4FDB-BD83-29C4D85B252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9D287A7-4E67-4825-8549-2CE233B7B702}"/>
              </a:ext>
            </a:extLst>
          </p:cNvPr>
          <p:cNvSpPr>
            <a:spLocks noGrp="1"/>
          </p:cNvSpPr>
          <p:nvPr>
            <p:ph type="dt" sz="half" idx="10"/>
          </p:nvPr>
        </p:nvSpPr>
        <p:spPr/>
        <p:txBody>
          <a:bodyPr/>
          <a:lstStyle/>
          <a:p>
            <a:fld id="{296E97E2-6761-46FF-B48E-E80B97A8F655}" type="datetimeFigureOut">
              <a:rPr lang="en-GB" smtClean="0"/>
              <a:t>15/04/2025</a:t>
            </a:fld>
            <a:endParaRPr lang="en-GB"/>
          </a:p>
        </p:txBody>
      </p:sp>
      <p:sp>
        <p:nvSpPr>
          <p:cNvPr id="6" name="Footer Placeholder 5">
            <a:extLst>
              <a:ext uri="{FF2B5EF4-FFF2-40B4-BE49-F238E27FC236}">
                <a16:creationId xmlns:a16="http://schemas.microsoft.com/office/drawing/2014/main" id="{B39D5B43-1D10-44D7-9329-2D734A5E574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8DBA00B-0818-4388-9EC9-000329D2FD8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6010592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CD8008-BD23-4FF3-B2C8-AEB1BFA1B9D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6C2C572-2629-4EB6-8B9C-6F580C9A4F2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4729891-84FF-4E29-8D3C-97CDFD2F137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6E97E2-6761-46FF-B48E-E80B97A8F655}" type="datetimeFigureOut">
              <a:rPr lang="en-GB" smtClean="0"/>
              <a:t>15/04/2025</a:t>
            </a:fld>
            <a:endParaRPr lang="en-GB"/>
          </a:p>
        </p:txBody>
      </p:sp>
      <p:sp>
        <p:nvSpPr>
          <p:cNvPr id="5" name="Footer Placeholder 4">
            <a:extLst>
              <a:ext uri="{FF2B5EF4-FFF2-40B4-BE49-F238E27FC236}">
                <a16:creationId xmlns:a16="http://schemas.microsoft.com/office/drawing/2014/main" id="{9AF1E135-001E-4D84-A68E-E24216B85A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5625D331-C372-4209-83CA-16098BF2E6B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969173B-FA73-46A4-8B32-B3953617FCB1}" type="slidenum">
              <a:rPr lang="en-GB" smtClean="0"/>
              <a:t>‹#›</a:t>
            </a:fld>
            <a:endParaRPr lang="en-GB"/>
          </a:p>
        </p:txBody>
      </p:sp>
    </p:spTree>
    <p:extLst>
      <p:ext uri="{BB962C8B-B14F-4D97-AF65-F5344CB8AC3E}">
        <p14:creationId xmlns:p14="http://schemas.microsoft.com/office/powerpoint/2010/main" val="29248439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B815CAE-7201-51A6-D946-55233B51B445}"/>
              </a:ext>
            </a:extLst>
          </p:cNvPr>
          <p:cNvSpPr txBox="1"/>
          <p:nvPr/>
        </p:nvSpPr>
        <p:spPr>
          <a:xfrm>
            <a:off x="80836" y="4731391"/>
            <a:ext cx="12030327" cy="646331"/>
          </a:xfrm>
          <a:prstGeom prst="rect">
            <a:avLst/>
          </a:prstGeom>
          <a:noFill/>
        </p:spPr>
        <p:txBody>
          <a:bodyPr wrap="square" rtlCol="0">
            <a:spAutoFit/>
          </a:bodyPr>
          <a:lstStyle/>
          <a:p>
            <a:pPr algn="just"/>
            <a:r>
              <a:rPr lang="en-GB" sz="1200" b="1" dirty="0">
                <a:latin typeface="Times New Roman" panose="02020603050405020304" pitchFamily="18" charset="0"/>
                <a:cs typeface="Times New Roman" panose="02020603050405020304" pitchFamily="18" charset="0"/>
              </a:rPr>
              <a:t>Figure S3. Relative expression of IS genes in single cell clones. </a:t>
            </a:r>
            <a:r>
              <a:rPr lang="en-GB" sz="1200" dirty="0">
                <a:latin typeface="Times New Roman" panose="02020603050405020304" pitchFamily="18" charset="0"/>
                <a:cs typeface="Times New Roman" panose="02020603050405020304" pitchFamily="18" charset="0"/>
              </a:rPr>
              <a:t>Single cell IPSC clones isolated from bulk infected </a:t>
            </a:r>
            <a:r>
              <a:rPr lang="en-GB" sz="1200" dirty="0" err="1">
                <a:latin typeface="Times New Roman" panose="02020603050405020304" pitchFamily="18" charset="0"/>
                <a:cs typeface="Times New Roman" panose="02020603050405020304" pitchFamily="18" charset="0"/>
              </a:rPr>
              <a:t>pHR</a:t>
            </a:r>
            <a:r>
              <a:rPr lang="en-GB" sz="1200" dirty="0">
                <a:latin typeface="Times New Roman" panose="02020603050405020304" pitchFamily="18" charset="0"/>
                <a:cs typeface="Times New Roman" panose="02020603050405020304" pitchFamily="18" charset="0"/>
              </a:rPr>
              <a:t> and </a:t>
            </a:r>
            <a:r>
              <a:rPr lang="en-GB" sz="1200" dirty="0" err="1">
                <a:latin typeface="Times New Roman" panose="02020603050405020304" pitchFamily="18" charset="0"/>
                <a:cs typeface="Times New Roman" panose="02020603050405020304" pitchFamily="18" charset="0"/>
              </a:rPr>
              <a:t>pHV</a:t>
            </a:r>
            <a:r>
              <a:rPr lang="en-GB" sz="1200" dirty="0">
                <a:latin typeface="Times New Roman" panose="02020603050405020304" pitchFamily="18" charset="0"/>
                <a:cs typeface="Times New Roman" panose="02020603050405020304" pitchFamily="18" charset="0"/>
              </a:rPr>
              <a:t> populations and expanded for DNA and RNA extraction. Isolated RNA was converted to cDNA for qPCR analysis of IS genes compared to uninfected iPSC. IS genes identified were found upregulated associated with </a:t>
            </a:r>
            <a:r>
              <a:rPr lang="en-GB" sz="1200" dirty="0" err="1">
                <a:latin typeface="Times New Roman" panose="02020603050405020304" pitchFamily="18" charset="0"/>
                <a:cs typeface="Times New Roman" panose="02020603050405020304" pitchFamily="18" charset="0"/>
              </a:rPr>
              <a:t>pHR</a:t>
            </a:r>
            <a:r>
              <a:rPr lang="en-GB" sz="1200" dirty="0">
                <a:latin typeface="Times New Roman" panose="02020603050405020304" pitchFamily="18" charset="0"/>
                <a:cs typeface="Times New Roman" panose="02020603050405020304" pitchFamily="18" charset="0"/>
              </a:rPr>
              <a:t> (A) or </a:t>
            </a:r>
            <a:r>
              <a:rPr lang="en-GB" sz="1200" dirty="0" err="1">
                <a:latin typeface="Times New Roman" panose="02020603050405020304" pitchFamily="18" charset="0"/>
                <a:cs typeface="Times New Roman" panose="02020603050405020304" pitchFamily="18" charset="0"/>
              </a:rPr>
              <a:t>pHV</a:t>
            </a:r>
            <a:r>
              <a:rPr lang="en-GB" sz="1200" dirty="0">
                <a:latin typeface="Times New Roman" panose="02020603050405020304" pitchFamily="18" charset="0"/>
                <a:cs typeface="Times New Roman" panose="02020603050405020304" pitchFamily="18" charset="0"/>
              </a:rPr>
              <a:t> (B) infection (p&lt;0.05).</a:t>
            </a:r>
          </a:p>
        </p:txBody>
      </p:sp>
      <p:graphicFrame>
        <p:nvGraphicFramePr>
          <p:cNvPr id="8" name="Chart 7">
            <a:extLst>
              <a:ext uri="{FF2B5EF4-FFF2-40B4-BE49-F238E27FC236}">
                <a16:creationId xmlns:a16="http://schemas.microsoft.com/office/drawing/2014/main" id="{1A862027-DADE-B74A-8E53-74306BD8E05B}"/>
              </a:ext>
            </a:extLst>
          </p:cNvPr>
          <p:cNvGraphicFramePr>
            <a:graphicFrameLocks/>
          </p:cNvGraphicFramePr>
          <p:nvPr>
            <p:extLst>
              <p:ext uri="{D42A27DB-BD31-4B8C-83A1-F6EECF244321}">
                <p14:modId xmlns:p14="http://schemas.microsoft.com/office/powerpoint/2010/main" val="1123673347"/>
              </p:ext>
            </p:extLst>
          </p:nvPr>
        </p:nvGraphicFramePr>
        <p:xfrm>
          <a:off x="0" y="258764"/>
          <a:ext cx="5936343" cy="422934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Chart 8">
            <a:extLst>
              <a:ext uri="{FF2B5EF4-FFF2-40B4-BE49-F238E27FC236}">
                <a16:creationId xmlns:a16="http://schemas.microsoft.com/office/drawing/2014/main" id="{559FA2BF-3E03-AA11-820F-F5CA8B872A9F}"/>
              </a:ext>
            </a:extLst>
          </p:cNvPr>
          <p:cNvGraphicFramePr>
            <a:graphicFrameLocks/>
          </p:cNvGraphicFramePr>
          <p:nvPr>
            <p:extLst>
              <p:ext uri="{D42A27DB-BD31-4B8C-83A1-F6EECF244321}">
                <p14:modId xmlns:p14="http://schemas.microsoft.com/office/powerpoint/2010/main" val="1571885202"/>
              </p:ext>
            </p:extLst>
          </p:nvPr>
        </p:nvGraphicFramePr>
        <p:xfrm>
          <a:off x="5936343" y="158097"/>
          <a:ext cx="6255657" cy="4573294"/>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a:extLst>
              <a:ext uri="{FF2B5EF4-FFF2-40B4-BE49-F238E27FC236}">
                <a16:creationId xmlns:a16="http://schemas.microsoft.com/office/drawing/2014/main" id="{3C43B083-E9D0-6677-C4B7-C0BD3CC172AC}"/>
              </a:ext>
            </a:extLst>
          </p:cNvPr>
          <p:cNvSpPr txBox="1"/>
          <p:nvPr/>
        </p:nvSpPr>
        <p:spPr>
          <a:xfrm>
            <a:off x="161672" y="258764"/>
            <a:ext cx="338614" cy="276999"/>
          </a:xfrm>
          <a:prstGeom prst="rect">
            <a:avLst/>
          </a:prstGeom>
          <a:noFill/>
        </p:spPr>
        <p:txBody>
          <a:bodyPr wrap="square" rtlCol="0">
            <a:spAutoFit/>
          </a:bodyPr>
          <a:lstStyle/>
          <a:p>
            <a:r>
              <a:rPr lang="en-GB" sz="1200" b="1" dirty="0"/>
              <a:t>A</a:t>
            </a:r>
          </a:p>
        </p:txBody>
      </p:sp>
      <p:sp>
        <p:nvSpPr>
          <p:cNvPr id="4" name="TextBox 3">
            <a:extLst>
              <a:ext uri="{FF2B5EF4-FFF2-40B4-BE49-F238E27FC236}">
                <a16:creationId xmlns:a16="http://schemas.microsoft.com/office/drawing/2014/main" id="{F8ABDA98-F871-8FE8-0F2F-47D4131F0253}"/>
              </a:ext>
            </a:extLst>
          </p:cNvPr>
          <p:cNvSpPr txBox="1"/>
          <p:nvPr/>
        </p:nvSpPr>
        <p:spPr>
          <a:xfrm>
            <a:off x="5917045" y="258764"/>
            <a:ext cx="338614" cy="276999"/>
          </a:xfrm>
          <a:prstGeom prst="rect">
            <a:avLst/>
          </a:prstGeom>
          <a:noFill/>
        </p:spPr>
        <p:txBody>
          <a:bodyPr wrap="square" rtlCol="0">
            <a:spAutoFit/>
          </a:bodyPr>
          <a:lstStyle/>
          <a:p>
            <a:r>
              <a:rPr lang="en-GB" sz="1200" b="1" dirty="0"/>
              <a:t>B</a:t>
            </a:r>
          </a:p>
        </p:txBody>
      </p:sp>
    </p:spTree>
    <p:extLst>
      <p:ext uri="{BB962C8B-B14F-4D97-AF65-F5344CB8AC3E}">
        <p14:creationId xmlns:p14="http://schemas.microsoft.com/office/powerpoint/2010/main" val="38205312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83</TotalTime>
  <Words>83</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qlain Suleman (Staff)</dc:creator>
  <cp:lastModifiedBy>Suleman, Saqlain</cp:lastModifiedBy>
  <cp:revision>30</cp:revision>
  <dcterms:created xsi:type="dcterms:W3CDTF">2024-01-05T10:52:35Z</dcterms:created>
  <dcterms:modified xsi:type="dcterms:W3CDTF">2025-04-15T09:52:56Z</dcterms:modified>
</cp:coreProperties>
</file>